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57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141CDC-8EDC-4C03-AAE2-DD88645A62F6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9D8A79-B35B-4DF6-833F-ED7C9DD4C2E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6631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Platelets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9D8A79-B35B-4DF6-833F-ED7C9DD4C2E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891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186103-E907-E2B7-C8DD-ED5D4DE0D0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BEAFEB2-B0A8-4572-F57C-B57922EB4C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616BFA-60FA-8C00-7A44-E04F21FA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96DE14-A45A-9955-662D-18A81BE50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2E6CF9B-899F-056B-26E3-4E4883EEE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4325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3F6BD13-DC24-9F71-31C5-D14618BA7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F0306D4-43EE-3328-C897-82A119E8FE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2455C9F-F79E-8F1C-70A8-323454EC7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90D6AB1-8A04-D592-5274-F7B047D8C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AA8137B-5839-D806-36CE-7B7248BB8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2930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B59B5D5-384C-973C-3872-591C450811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24F2E6F-32BA-49B3-A702-48328B4E4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7D674D6-F533-9712-EF52-FFA471DC0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E4A4B1-AEF7-C565-C98B-150C34CE7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CED002-6218-A227-A4C4-B74805C03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9770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0143415-770D-DA38-7EE7-B767BAC321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44F4D23-29A9-62ED-C48D-F9BB7ECADC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DE8F67B-E3FA-0272-23A7-8FD7067D1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3D7662-2964-CE3D-D9E1-FDC9B4CE9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0AA0B5-6F31-A4B2-FBCC-D4E8D6AE4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2483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30994CB-7A0E-929D-68E7-85FD6BFDF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3862926-5E99-EB73-1C65-6AC58CF517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1D1EE8-A75D-F32F-9D79-9CD653A97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FBB921-05EE-1AC2-BB96-6D17E63C2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FF6F239-6353-856E-9BF0-8DF4FC0C2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7798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32AD68-1683-4A22-F4ED-FA1D243C94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735B394-21BC-13DA-08EC-9E520D33D1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236AD0D-1566-6FF1-AB6F-5F253B61AD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553B34A-7426-D2E6-0467-8DFD7024F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373BB2A-63B2-AB5F-FBD9-A00626AA1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DDCCCF1-F719-2EC2-C2BD-6F57FD159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713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32CC35-1D6F-E8C5-1DFE-CD7E8F4D8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4D87C7E-0FE2-5886-B4FD-F24ABDC653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192845C-268C-FEFE-A85D-98020787D9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08439A1-1CE0-E110-5F38-7D4A8F297A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E634F75-8E27-033B-22C1-62D5BF4D8C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D1E6798-D540-1871-07EF-51F94E949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65B44A2-450A-3231-CEDA-8E7EA598D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C1376EC-16E1-54E4-DCD6-4034FC9E1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599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B4E0AC-334E-764E-CAB0-BA9EA8E5E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6B271B4-4088-7078-E96D-31DFE302C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4B7565D-EA06-D02D-5DAB-334C2B7A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BCBA51F-24C5-6F50-2DE2-26741076B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9248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59FC86D-85B4-C4CC-4952-9A0CA3E90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9DC3A47-F1C4-C753-34C0-A281991F8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825B4CF-73BC-2122-E62D-C3F16E058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2586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A88B686-A63E-7921-4496-6625E7699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1326F99-5911-B1B3-D5DF-4CAA96F2FB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46F26AD-3E3B-ACE7-4405-D81A25A0F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56C0932-6227-6C95-BD02-C75D27AEC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C067F8C-5E2C-2340-87CF-205E0512F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06332AF-6794-DC3B-E91A-F969DAF88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582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446FF6-DB8D-7271-9158-FDCCB2E4B7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2683BC0-7DE3-72F5-B856-62815A3D56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F1E2F1C-3586-583C-051F-FFD7736E57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4D8B45D-6D32-F0E1-BF6F-D744D9E31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EBD33CA-748E-FD71-3293-CFC113464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A7D15BA-7958-4195-1AD1-12221EBD7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3677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DD9101F-E14D-4A59-2ABE-9A80E6999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9C2218A-2095-AE10-8942-BAEE4722B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A3BDBAE-857B-EE47-BB8C-99FE79A592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85B304-EB4D-4457-8666-8930E4FA0140}" type="datetimeFigureOut">
              <a:rPr lang="de-DE" smtClean="0"/>
              <a:t>07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748B543-E39D-E194-7CA6-14F1B98869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3F8A81A-6064-D1E8-6C99-92AB319F30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F13E0A-7433-489C-9294-83EA8B235D6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4566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4BB016F9-29F7-EF66-624E-51702630D64A}"/>
              </a:ext>
            </a:extLst>
          </p:cNvPr>
          <p:cNvSpPr txBox="1"/>
          <p:nvPr/>
        </p:nvSpPr>
        <p:spPr>
          <a:xfrm>
            <a:off x="4180879" y="314325"/>
            <a:ext cx="385822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6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Ct, </a:t>
            </a:r>
            <a:r>
              <a:rPr lang="de-DE" sz="1600" b="1">
                <a:latin typeface="Symbol" panose="05050102010706020507" pitchFamily="18" charset="2"/>
                <a:cs typeface="Arial" panose="020B0604020202020204" pitchFamily="34" charset="0"/>
              </a:rPr>
              <a:t>DD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Ct, 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C847D61-00DC-8B0B-F5EC-E4A31959AD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2172966"/>
              </p:ext>
            </p:extLst>
          </p:nvPr>
        </p:nvGraphicFramePr>
        <p:xfrm>
          <a:off x="552450" y="766527"/>
          <a:ext cx="11096206" cy="555284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8746">
                  <a:extLst>
                    <a:ext uri="{9D8B030D-6E8A-4147-A177-3AD203B41FA5}">
                      <a16:colId xmlns:a16="http://schemas.microsoft.com/office/drawing/2014/main" val="1555231713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3329008895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1068498898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3117013949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175048192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1856885786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3901191735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609706357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4294004282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2216112049"/>
                    </a:ext>
                  </a:extLst>
                </a:gridCol>
                <a:gridCol w="1008746">
                  <a:extLst>
                    <a:ext uri="{9D8B030D-6E8A-4147-A177-3AD203B41FA5}">
                      <a16:colId xmlns:a16="http://schemas.microsoft.com/office/drawing/2014/main" val="535663738"/>
                    </a:ext>
                  </a:extLst>
                </a:gridCol>
              </a:tblGrid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Proband/Pa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Tumor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81</a:t>
                      </a:r>
                      <a:r>
                        <a:rPr lang="de-DE" sz="13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300" b="1" u="none" strike="noStrike">
                          <a:effectLst/>
                        </a:rPr>
                        <a:t>C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43</a:t>
                      </a:r>
                      <a:r>
                        <a:rPr lang="de-DE" sz="13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300" b="1" u="none" strike="noStrike">
                          <a:effectLst/>
                        </a:rPr>
                        <a:t>C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45</a:t>
                      </a:r>
                      <a:r>
                        <a:rPr lang="de-DE" sz="13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1300" b="1" u="none" strike="noStrike">
                          <a:effectLst/>
                        </a:rPr>
                        <a:t>C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81</a:t>
                      </a:r>
                      <a:r>
                        <a:rPr lang="de-DE" sz="13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300" b="1" u="none" strike="noStrike">
                          <a:effectLst/>
                        </a:rPr>
                        <a:t>C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43</a:t>
                      </a:r>
                      <a:r>
                        <a:rPr lang="de-DE" sz="13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300" b="1" u="none" strike="noStrike">
                          <a:effectLst/>
                        </a:rPr>
                        <a:t>C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45</a:t>
                      </a:r>
                      <a:r>
                        <a:rPr lang="de-DE" sz="13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1300" b="1" u="none" strike="noStrike">
                          <a:effectLst/>
                        </a:rPr>
                        <a:t>Ct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81fold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43fold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miR-145fold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887675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1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18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1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41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03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51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08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02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42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06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4060386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2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43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18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02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21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63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47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85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55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39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1894230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3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82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22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70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39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60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79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31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51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73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651190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4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45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55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59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1,75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27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90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8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20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87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2884915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5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7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7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75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42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10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74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34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07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68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3859973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6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8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6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2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33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1,21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1,25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26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32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38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4720425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7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56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53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79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35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0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29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8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1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81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0519990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8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7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88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91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84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5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1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79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96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5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4436359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09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9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83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9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22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00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41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16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9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37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550616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10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38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42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29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17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0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9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4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5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7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3309461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11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61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51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25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0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30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24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5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23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18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0951265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Healthy12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6,07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0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0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86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28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60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27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1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32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5910978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6448383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Ench01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73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49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98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2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6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48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9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35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1419021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Ench02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0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29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42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88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29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91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4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2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2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269734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Ench03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67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7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89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67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20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3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3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9327602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Ench04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89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4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02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7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4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48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2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9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39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5918151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Ench05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09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9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16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87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9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6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4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2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3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3293497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Ench06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71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95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13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50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95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2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35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1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4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733237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5640106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Chondros01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73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99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55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2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99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05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9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3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48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0044318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Chondros02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49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47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50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28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47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99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82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17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994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0624670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Chondros03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5,16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1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14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94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1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35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1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5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28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6130845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Chondros04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6,00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74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252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78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74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48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2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3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596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7403814"/>
                  </a:ext>
                </a:extLst>
              </a:tr>
              <a:tr h="21357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1300" b="1" u="none" strike="noStrike">
                          <a:effectLst/>
                        </a:rPr>
                        <a:t>Chondros05</a:t>
                      </a:r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4,93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3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2,82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72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3,335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-0,67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607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0,099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1300" u="none" strike="noStrike">
                          <a:effectLst/>
                        </a:rPr>
                        <a:t>1,601</a:t>
                      </a:r>
                      <a:endParaRPr lang="de-DE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407" marR="8407" marT="8407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9412477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2035A22C-2E62-F0FD-BF0D-1137214B8C9D}"/>
              </a:ext>
            </a:extLst>
          </p:cNvPr>
          <p:cNvSpPr/>
          <p:nvPr/>
        </p:nvSpPr>
        <p:spPr>
          <a:xfrm>
            <a:off x="542925" y="776052"/>
            <a:ext cx="11115256" cy="555284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3167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2</Words>
  <Application>Microsoft Office PowerPoint</Application>
  <PresentationFormat>Widescreen</PresentationFormat>
  <Paragraphs>26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</vt:lpstr>
      <vt:lpstr>PowerPoint Presentation</vt:lpstr>
    </vt:vector>
  </TitlesOfParts>
  <Company>UKJ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chrenk, Karin</dc:creator>
  <cp:lastModifiedBy>Karin Schrenk</cp:lastModifiedBy>
  <cp:revision>9</cp:revision>
  <dcterms:created xsi:type="dcterms:W3CDTF">2026-02-17T09:58:21Z</dcterms:created>
  <dcterms:modified xsi:type="dcterms:W3CDTF">2026-04-07T09:13:19Z</dcterms:modified>
</cp:coreProperties>
</file>